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6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1890" y="12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D36470-BE77-5410-B5CC-04000B2A27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5078DF5-76D3-4D8A-B479-09CB199E43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004D6C-CDB8-3FE7-9BDC-CD085F46B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F4784-7CA5-4326-976E-FB456276DDC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80D17DC-2527-5232-B739-A74EE95B56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365BC4C-3866-B64B-818B-C7F06CA82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2164-2E35-47FD-A619-B27102508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0802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6D8B15-F874-47A8-D8E9-2560A212E7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693CA32-1EBA-B444-02A9-4BA019A2A0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19DE4B6-A137-8EED-3786-00BE6A9B11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F4784-7CA5-4326-976E-FB456276DDC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469B15-0C14-FF06-8B03-1080AABC8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69B90C4-BD96-E6D1-6775-74E5884216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2164-2E35-47FD-A619-B27102508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1703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46D48EE-D482-C3D2-A8CE-BE5A1BE336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D8DD98A-6BD8-9FB5-BC81-7E12C32640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F0C909-94E5-457E-C232-4D7D491EDC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F4784-7CA5-4326-976E-FB456276DDC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3C19A4E-D347-E301-1099-CF2A468F3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6EA757B-8C9D-CCD1-C68D-8DD9044C6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2164-2E35-47FD-A619-B27102508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445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0DEAF4-DD14-DDD3-4FA6-93EEBFBAC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F1B9F8F-B134-AD98-8531-1188083E82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2FC14A-D2B7-416E-E231-17DF9D753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F4784-7CA5-4326-976E-FB456276DDC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F7E619-CC92-DFA5-0159-B29BAD631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590CF7-621E-DA97-2278-6AEB41632B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2164-2E35-47FD-A619-B27102508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9245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33B8C9-3548-8061-9191-1C2B8A4427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3B5A4D9-D618-2982-93EA-90D764214C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4BFEACD-F8AC-3D82-E781-2DAC322DD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F4784-7CA5-4326-976E-FB456276DDC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ACAE8E-622B-40D7-850A-36F9DF2BD5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7B3655C-7A9C-26F0-C7B1-C391962A9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2164-2E35-47FD-A619-B27102508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91487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461DDF-9CFC-D4BB-7D4D-A9077A35E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3F84C7-9724-DE12-3FAA-81E2C9BB24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53266CD-4D02-54F6-C1EC-933EACDAAE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8B0E34B-495D-C394-C0F7-EDC6428FF7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F4784-7CA5-4326-976E-FB456276DDC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93679E2-9AE0-11A7-3BCF-06FC2E4F7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D9DD059-A821-D5C1-D7F4-621DBEEB6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2164-2E35-47FD-A619-B27102508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30447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20CAA0-3665-F33C-4050-6C50957827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AA728AF-46FD-3ABA-A1D1-CF1FFC0130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254274F-C5E2-992C-EEE5-212C7BD170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817D592-11B2-36CF-007B-8804C00BB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EA042BD-48A1-A0A5-B75C-D454DEB8FF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5699376-E33D-A1DF-8ACA-CB67ECA6F8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F4784-7CA5-4326-976E-FB456276DDC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60D55BF-0FA0-B12A-6908-37385A57C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47A88A1-65B0-B1BE-85E3-0305EFE26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2164-2E35-47FD-A619-B27102508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0595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E3DF8E3-6319-702B-58F5-96EE20C20D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2DDF989-EFB4-CFD3-13AD-F20304C527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F4784-7CA5-4326-976E-FB456276DDC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FEDA185-7C68-6504-EFA4-77AB8F2F07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84CE2FE-8961-8DF6-9A2F-78792E1FED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2164-2E35-47FD-A619-B27102508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2561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CA8FA7C-4EE1-36BB-B7C9-C98D12F3B8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F4784-7CA5-4326-976E-FB456276DDC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638C385-C09E-A3EC-5CDD-014DB1D7E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AD312A9-0692-2BAF-F985-5668F4B97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2164-2E35-47FD-A619-B27102508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6876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F7A821-0A2E-5758-8897-3D2A897B8A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4BE0A1C-A153-2084-F1C8-6E3BC7C623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4206F97-B8B0-E6E1-2F6E-D616B1A936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A711EBE-CB2B-E33E-80D8-8C5AE1140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F4784-7CA5-4326-976E-FB456276DDC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D74F665-8659-C085-425E-1C86FA76F8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BCC20FA-BF9D-85FA-0BB7-837A76D01B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2164-2E35-47FD-A619-B27102508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0725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AD4958-467C-F0E9-A40E-0E52231653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D466043-7356-5606-3381-A09EA4CECA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D32CDA5-6236-6D20-3142-C512787B48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2B32B47-439E-AD91-477E-CA443287B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F4784-7CA5-4326-976E-FB456276DDC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3F46D99-D7AA-D4F3-09E5-BD225B5491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ACC2538-49DD-B2FE-92D2-56481696E4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2164-2E35-47FD-A619-B27102508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0700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64619CE-161B-EAE8-0EF8-E26CD139B4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42DF62C-4A66-F479-E32D-213807BA92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841102-5D8D-BAF3-3984-DBCE3A8F87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44F4784-7CA5-4326-976E-FB456276DDC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CF02E54-F6F7-CAB2-DEDD-8AA49595BD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52C88B-DB2B-D1A5-F538-DA1F403C55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132164-2E35-47FD-A619-B271025088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14084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表, 直方图&#10;&#10;AI 生成的内容可能不正确。">
            <a:extLst>
              <a:ext uri="{FF2B5EF4-FFF2-40B4-BE49-F238E27FC236}">
                <a16:creationId xmlns:a16="http://schemas.microsoft.com/office/drawing/2014/main" id="{F9986672-C277-4A37-115B-5EEE81BF6F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885" y="394814"/>
            <a:ext cx="10387584" cy="3197352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21254B82-69B9-8A4F-C7D6-28A5A285D28B}"/>
              </a:ext>
            </a:extLst>
          </p:cNvPr>
          <p:cNvSpPr txBox="1"/>
          <p:nvPr/>
        </p:nvSpPr>
        <p:spPr>
          <a:xfrm>
            <a:off x="803886" y="3956611"/>
            <a:ext cx="10387583" cy="16758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S1 NDV infection inhibits the transcriptional levels of FLCN and enzymes associated with de novo fatty acid synthesis. A-E.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DF-1 cells were MOCK- or NDV-infected at an MOI of 1 and RNA was extracted 18 h p i for quantitative PCR analysis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60797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B00D5694-7825-B771-FC02-859C4CA39992}"/>
              </a:ext>
            </a:extLst>
          </p:cNvPr>
          <p:cNvSpPr txBox="1"/>
          <p:nvPr/>
        </p:nvSpPr>
        <p:spPr>
          <a:xfrm>
            <a:off x="897636" y="4689166"/>
            <a:ext cx="10396728" cy="11218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S2 FLCN</a:t>
            </a:r>
            <a:r>
              <a:rPr lang="en-US" altLang="zh-CN" sz="1800" b="1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ell line identification. A.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oth genomes in the cell line were subjected to frameshift mutations under the action of sgRNA, proving it to be a double knockout cell line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 descr="图形用户界面, 文本, 应用程序&#10;&#10;AI 生成的内容可能不正确。">
            <a:extLst>
              <a:ext uri="{FF2B5EF4-FFF2-40B4-BE49-F238E27FC236}">
                <a16:creationId xmlns:a16="http://schemas.microsoft.com/office/drawing/2014/main" id="{58074C64-116E-8A86-112A-D371F1C15A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636" y="1046988"/>
            <a:ext cx="10396728" cy="32400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57031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913B6286-9AC3-2FA5-D95E-5A90CDB7674E}"/>
              </a:ext>
            </a:extLst>
          </p:cNvPr>
          <p:cNvSpPr txBox="1"/>
          <p:nvPr/>
        </p:nvSpPr>
        <p:spPr>
          <a:xfrm>
            <a:off x="704850" y="4188183"/>
            <a:ext cx="10896600" cy="22298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S3 Overexpression of FLCN in the DF-1 cell line inhibits NDV replication. A.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iral proteins NP and HN were used to indicate viral replication levels. DF-1 cells were transfected with </a:t>
            </a:r>
            <a:r>
              <a:rPr lang="en-US" altLang="zh-CN" sz="18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CMV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HA-FLCN for 24 hours and infected with NDV at an MOI of 0.01, and cell samples were collected every 6 hours. HA levels were measured to reflect FLCN transfection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 descr="散点图&#10;&#10;AI 生成的内容可能不正确。">
            <a:extLst>
              <a:ext uri="{FF2B5EF4-FFF2-40B4-BE49-F238E27FC236}">
                <a16:creationId xmlns:a16="http://schemas.microsoft.com/office/drawing/2014/main" id="{51257E6D-047A-F1A0-65A4-46E00D9F08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350" y="1139107"/>
            <a:ext cx="11087100" cy="26323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5036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2</Words>
  <Application>Microsoft Office PowerPoint</Application>
  <PresentationFormat>宽屏</PresentationFormat>
  <Paragraphs>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梦青 杨</dc:creator>
  <cp:lastModifiedBy>梦青 杨</cp:lastModifiedBy>
  <cp:revision>1</cp:revision>
  <dcterms:created xsi:type="dcterms:W3CDTF">2025-05-09T13:33:07Z</dcterms:created>
  <dcterms:modified xsi:type="dcterms:W3CDTF">2025-05-09T13:35:48Z</dcterms:modified>
</cp:coreProperties>
</file>